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7848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97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284482"/>
            <a:ext cx="10363200" cy="2732476"/>
          </a:xfrm>
        </p:spPr>
        <p:txBody>
          <a:bodyPr anchor="b"/>
          <a:lstStyle>
            <a:lvl1pPr algn="ctr">
              <a:defRPr sz="6866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122332"/>
            <a:ext cx="9144000" cy="1894928"/>
          </a:xfrm>
        </p:spPr>
        <p:txBody>
          <a:bodyPr/>
          <a:lstStyle>
            <a:lvl1pPr marL="0" indent="0" algn="ctr">
              <a:buNone/>
              <a:defRPr sz="2747"/>
            </a:lvl1pPr>
            <a:lvl2pPr marL="523220" indent="0" algn="ctr">
              <a:buNone/>
              <a:defRPr sz="2289"/>
            </a:lvl2pPr>
            <a:lvl3pPr marL="1046439" indent="0" algn="ctr">
              <a:buNone/>
              <a:defRPr sz="2060"/>
            </a:lvl3pPr>
            <a:lvl4pPr marL="1569659" indent="0" algn="ctr">
              <a:buNone/>
              <a:defRPr sz="1831"/>
            </a:lvl4pPr>
            <a:lvl5pPr marL="2092879" indent="0" algn="ctr">
              <a:buNone/>
              <a:defRPr sz="1831"/>
            </a:lvl5pPr>
            <a:lvl6pPr marL="2616098" indent="0" algn="ctr">
              <a:buNone/>
              <a:defRPr sz="1831"/>
            </a:lvl6pPr>
            <a:lvl7pPr marL="3139318" indent="0" algn="ctr">
              <a:buNone/>
              <a:defRPr sz="1831"/>
            </a:lvl7pPr>
            <a:lvl8pPr marL="3662538" indent="0" algn="ctr">
              <a:buNone/>
              <a:defRPr sz="1831"/>
            </a:lvl8pPr>
            <a:lvl9pPr marL="4185757" indent="0" algn="ctr">
              <a:buNone/>
              <a:defRPr sz="1831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B0C03-E959-4A3B-9766-C52C7221598F}" type="datetimeFigureOut">
              <a:rPr lang="el-GR" smtClean="0"/>
              <a:t>2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52DC-F1C0-4F9B-BB8D-5FB30173527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626270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B0C03-E959-4A3B-9766-C52C7221598F}" type="datetimeFigureOut">
              <a:rPr lang="el-GR" smtClean="0"/>
              <a:t>2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52DC-F1C0-4F9B-BB8D-5FB30173527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2738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17865"/>
            <a:ext cx="2628900" cy="6651326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17865"/>
            <a:ext cx="7734300" cy="6651326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B0C03-E959-4A3B-9766-C52C7221598F}" type="datetimeFigureOut">
              <a:rPr lang="el-GR" smtClean="0"/>
              <a:t>2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52DC-F1C0-4F9B-BB8D-5FB30173527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646530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B0C03-E959-4A3B-9766-C52C7221598F}" type="datetimeFigureOut">
              <a:rPr lang="el-GR" smtClean="0"/>
              <a:t>2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52DC-F1C0-4F9B-BB8D-5FB30173527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961138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956702"/>
            <a:ext cx="10515600" cy="3264799"/>
          </a:xfrm>
        </p:spPr>
        <p:txBody>
          <a:bodyPr anchor="b"/>
          <a:lstStyle>
            <a:lvl1pPr>
              <a:defRPr sz="6866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252387"/>
            <a:ext cx="10515600" cy="1716881"/>
          </a:xfrm>
        </p:spPr>
        <p:txBody>
          <a:bodyPr/>
          <a:lstStyle>
            <a:lvl1pPr marL="0" indent="0">
              <a:buNone/>
              <a:defRPr sz="2747">
                <a:solidFill>
                  <a:schemeClr val="tx1"/>
                </a:solidFill>
              </a:defRPr>
            </a:lvl1pPr>
            <a:lvl2pPr marL="523220" indent="0">
              <a:buNone/>
              <a:defRPr sz="2289">
                <a:solidFill>
                  <a:schemeClr val="tx1">
                    <a:tint val="75000"/>
                  </a:schemeClr>
                </a:solidFill>
              </a:defRPr>
            </a:lvl2pPr>
            <a:lvl3pPr marL="1046439" indent="0">
              <a:buNone/>
              <a:defRPr sz="2060">
                <a:solidFill>
                  <a:schemeClr val="tx1">
                    <a:tint val="75000"/>
                  </a:schemeClr>
                </a:solidFill>
              </a:defRPr>
            </a:lvl3pPr>
            <a:lvl4pPr marL="1569659" indent="0">
              <a:buNone/>
              <a:defRPr sz="1831">
                <a:solidFill>
                  <a:schemeClr val="tx1">
                    <a:tint val="75000"/>
                  </a:schemeClr>
                </a:solidFill>
              </a:defRPr>
            </a:lvl4pPr>
            <a:lvl5pPr marL="2092879" indent="0">
              <a:buNone/>
              <a:defRPr sz="1831">
                <a:solidFill>
                  <a:schemeClr val="tx1">
                    <a:tint val="75000"/>
                  </a:schemeClr>
                </a:solidFill>
              </a:defRPr>
            </a:lvl5pPr>
            <a:lvl6pPr marL="2616098" indent="0">
              <a:buNone/>
              <a:defRPr sz="1831">
                <a:solidFill>
                  <a:schemeClr val="tx1">
                    <a:tint val="75000"/>
                  </a:schemeClr>
                </a:solidFill>
              </a:defRPr>
            </a:lvl6pPr>
            <a:lvl7pPr marL="3139318" indent="0">
              <a:buNone/>
              <a:defRPr sz="1831">
                <a:solidFill>
                  <a:schemeClr val="tx1">
                    <a:tint val="75000"/>
                  </a:schemeClr>
                </a:solidFill>
              </a:defRPr>
            </a:lvl7pPr>
            <a:lvl8pPr marL="3662538" indent="0">
              <a:buNone/>
              <a:defRPr sz="1831">
                <a:solidFill>
                  <a:schemeClr val="tx1">
                    <a:tint val="75000"/>
                  </a:schemeClr>
                </a:solidFill>
              </a:defRPr>
            </a:lvl8pPr>
            <a:lvl9pPr marL="4185757" indent="0">
              <a:buNone/>
              <a:defRPr sz="183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B0C03-E959-4A3B-9766-C52C7221598F}" type="datetimeFigureOut">
              <a:rPr lang="el-GR" smtClean="0"/>
              <a:t>2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52DC-F1C0-4F9B-BB8D-5FB30173527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950301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089326"/>
            <a:ext cx="5181600" cy="4979865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089326"/>
            <a:ext cx="5181600" cy="4979865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B0C03-E959-4A3B-9766-C52C7221598F}" type="datetimeFigureOut">
              <a:rPr lang="el-GR" smtClean="0"/>
              <a:t>2/6/2024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52DC-F1C0-4F9B-BB8D-5FB30173527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331717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17867"/>
            <a:ext cx="10515600" cy="1517033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923997"/>
            <a:ext cx="5157787" cy="942922"/>
          </a:xfrm>
        </p:spPr>
        <p:txBody>
          <a:bodyPr anchor="b"/>
          <a:lstStyle>
            <a:lvl1pPr marL="0" indent="0">
              <a:buNone/>
              <a:defRPr sz="2747" b="1"/>
            </a:lvl1pPr>
            <a:lvl2pPr marL="523220" indent="0">
              <a:buNone/>
              <a:defRPr sz="2289" b="1"/>
            </a:lvl2pPr>
            <a:lvl3pPr marL="1046439" indent="0">
              <a:buNone/>
              <a:defRPr sz="2060" b="1"/>
            </a:lvl3pPr>
            <a:lvl4pPr marL="1569659" indent="0">
              <a:buNone/>
              <a:defRPr sz="1831" b="1"/>
            </a:lvl4pPr>
            <a:lvl5pPr marL="2092879" indent="0">
              <a:buNone/>
              <a:defRPr sz="1831" b="1"/>
            </a:lvl5pPr>
            <a:lvl6pPr marL="2616098" indent="0">
              <a:buNone/>
              <a:defRPr sz="1831" b="1"/>
            </a:lvl6pPr>
            <a:lvl7pPr marL="3139318" indent="0">
              <a:buNone/>
              <a:defRPr sz="1831" b="1"/>
            </a:lvl7pPr>
            <a:lvl8pPr marL="3662538" indent="0">
              <a:buNone/>
              <a:defRPr sz="1831" b="1"/>
            </a:lvl8pPr>
            <a:lvl9pPr marL="4185757" indent="0">
              <a:buNone/>
              <a:defRPr sz="1831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866919"/>
            <a:ext cx="5157787" cy="4216806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923997"/>
            <a:ext cx="5183188" cy="942922"/>
          </a:xfrm>
        </p:spPr>
        <p:txBody>
          <a:bodyPr anchor="b"/>
          <a:lstStyle>
            <a:lvl1pPr marL="0" indent="0">
              <a:buNone/>
              <a:defRPr sz="2747" b="1"/>
            </a:lvl1pPr>
            <a:lvl2pPr marL="523220" indent="0">
              <a:buNone/>
              <a:defRPr sz="2289" b="1"/>
            </a:lvl2pPr>
            <a:lvl3pPr marL="1046439" indent="0">
              <a:buNone/>
              <a:defRPr sz="2060" b="1"/>
            </a:lvl3pPr>
            <a:lvl4pPr marL="1569659" indent="0">
              <a:buNone/>
              <a:defRPr sz="1831" b="1"/>
            </a:lvl4pPr>
            <a:lvl5pPr marL="2092879" indent="0">
              <a:buNone/>
              <a:defRPr sz="1831" b="1"/>
            </a:lvl5pPr>
            <a:lvl6pPr marL="2616098" indent="0">
              <a:buNone/>
              <a:defRPr sz="1831" b="1"/>
            </a:lvl6pPr>
            <a:lvl7pPr marL="3139318" indent="0">
              <a:buNone/>
              <a:defRPr sz="1831" b="1"/>
            </a:lvl7pPr>
            <a:lvl8pPr marL="3662538" indent="0">
              <a:buNone/>
              <a:defRPr sz="1831" b="1"/>
            </a:lvl8pPr>
            <a:lvl9pPr marL="4185757" indent="0">
              <a:buNone/>
              <a:defRPr sz="1831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866919"/>
            <a:ext cx="5183188" cy="4216806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B0C03-E959-4A3B-9766-C52C7221598F}" type="datetimeFigureOut">
              <a:rPr lang="el-GR" smtClean="0"/>
              <a:t>2/6/2024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52DC-F1C0-4F9B-BB8D-5FB30173527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702177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B0C03-E959-4A3B-9766-C52C7221598F}" type="datetimeFigureOut">
              <a:rPr lang="el-GR" smtClean="0"/>
              <a:t>2/6/2024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52DC-F1C0-4F9B-BB8D-5FB30173527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78766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B0C03-E959-4A3B-9766-C52C7221598F}" type="datetimeFigureOut">
              <a:rPr lang="el-GR" smtClean="0"/>
              <a:t>2/6/2024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52DC-F1C0-4F9B-BB8D-5FB30173527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275497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23240"/>
            <a:ext cx="3932237" cy="1831340"/>
          </a:xfrm>
        </p:spPr>
        <p:txBody>
          <a:bodyPr anchor="b"/>
          <a:lstStyle>
            <a:lvl1pPr>
              <a:defRPr sz="3662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30055"/>
            <a:ext cx="6172200" cy="5577593"/>
          </a:xfrm>
        </p:spPr>
        <p:txBody>
          <a:bodyPr/>
          <a:lstStyle>
            <a:lvl1pPr>
              <a:defRPr sz="3662"/>
            </a:lvl1pPr>
            <a:lvl2pPr>
              <a:defRPr sz="3204"/>
            </a:lvl2pPr>
            <a:lvl3pPr>
              <a:defRPr sz="2747"/>
            </a:lvl3pPr>
            <a:lvl4pPr>
              <a:defRPr sz="2289"/>
            </a:lvl4pPr>
            <a:lvl5pPr>
              <a:defRPr sz="2289"/>
            </a:lvl5pPr>
            <a:lvl6pPr>
              <a:defRPr sz="2289"/>
            </a:lvl6pPr>
            <a:lvl7pPr>
              <a:defRPr sz="2289"/>
            </a:lvl7pPr>
            <a:lvl8pPr>
              <a:defRPr sz="2289"/>
            </a:lvl8pPr>
            <a:lvl9pPr>
              <a:defRPr sz="2289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354580"/>
            <a:ext cx="3932237" cy="4362151"/>
          </a:xfrm>
        </p:spPr>
        <p:txBody>
          <a:bodyPr/>
          <a:lstStyle>
            <a:lvl1pPr marL="0" indent="0">
              <a:buNone/>
              <a:defRPr sz="1831"/>
            </a:lvl1pPr>
            <a:lvl2pPr marL="523220" indent="0">
              <a:buNone/>
              <a:defRPr sz="1602"/>
            </a:lvl2pPr>
            <a:lvl3pPr marL="1046439" indent="0">
              <a:buNone/>
              <a:defRPr sz="1373"/>
            </a:lvl3pPr>
            <a:lvl4pPr marL="1569659" indent="0">
              <a:buNone/>
              <a:defRPr sz="1144"/>
            </a:lvl4pPr>
            <a:lvl5pPr marL="2092879" indent="0">
              <a:buNone/>
              <a:defRPr sz="1144"/>
            </a:lvl5pPr>
            <a:lvl6pPr marL="2616098" indent="0">
              <a:buNone/>
              <a:defRPr sz="1144"/>
            </a:lvl6pPr>
            <a:lvl7pPr marL="3139318" indent="0">
              <a:buNone/>
              <a:defRPr sz="1144"/>
            </a:lvl7pPr>
            <a:lvl8pPr marL="3662538" indent="0">
              <a:buNone/>
              <a:defRPr sz="1144"/>
            </a:lvl8pPr>
            <a:lvl9pPr marL="4185757" indent="0">
              <a:buNone/>
              <a:defRPr sz="1144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B0C03-E959-4A3B-9766-C52C7221598F}" type="datetimeFigureOut">
              <a:rPr lang="el-GR" smtClean="0"/>
              <a:t>2/6/2024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52DC-F1C0-4F9B-BB8D-5FB30173527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11684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23240"/>
            <a:ext cx="3932237" cy="1831340"/>
          </a:xfrm>
        </p:spPr>
        <p:txBody>
          <a:bodyPr anchor="b"/>
          <a:lstStyle>
            <a:lvl1pPr>
              <a:defRPr sz="3662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30055"/>
            <a:ext cx="6172200" cy="5577593"/>
          </a:xfrm>
        </p:spPr>
        <p:txBody>
          <a:bodyPr anchor="t"/>
          <a:lstStyle>
            <a:lvl1pPr marL="0" indent="0">
              <a:buNone/>
              <a:defRPr sz="3662"/>
            </a:lvl1pPr>
            <a:lvl2pPr marL="523220" indent="0">
              <a:buNone/>
              <a:defRPr sz="3204"/>
            </a:lvl2pPr>
            <a:lvl3pPr marL="1046439" indent="0">
              <a:buNone/>
              <a:defRPr sz="2747"/>
            </a:lvl3pPr>
            <a:lvl4pPr marL="1569659" indent="0">
              <a:buNone/>
              <a:defRPr sz="2289"/>
            </a:lvl4pPr>
            <a:lvl5pPr marL="2092879" indent="0">
              <a:buNone/>
              <a:defRPr sz="2289"/>
            </a:lvl5pPr>
            <a:lvl6pPr marL="2616098" indent="0">
              <a:buNone/>
              <a:defRPr sz="2289"/>
            </a:lvl6pPr>
            <a:lvl7pPr marL="3139318" indent="0">
              <a:buNone/>
              <a:defRPr sz="2289"/>
            </a:lvl7pPr>
            <a:lvl8pPr marL="3662538" indent="0">
              <a:buNone/>
              <a:defRPr sz="2289"/>
            </a:lvl8pPr>
            <a:lvl9pPr marL="4185757" indent="0">
              <a:buNone/>
              <a:defRPr sz="2289"/>
            </a:lvl9pPr>
          </a:lstStyle>
          <a:p>
            <a:r>
              <a:rPr lang="el-GR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354580"/>
            <a:ext cx="3932237" cy="4362151"/>
          </a:xfrm>
        </p:spPr>
        <p:txBody>
          <a:bodyPr/>
          <a:lstStyle>
            <a:lvl1pPr marL="0" indent="0">
              <a:buNone/>
              <a:defRPr sz="1831"/>
            </a:lvl1pPr>
            <a:lvl2pPr marL="523220" indent="0">
              <a:buNone/>
              <a:defRPr sz="1602"/>
            </a:lvl2pPr>
            <a:lvl3pPr marL="1046439" indent="0">
              <a:buNone/>
              <a:defRPr sz="1373"/>
            </a:lvl3pPr>
            <a:lvl4pPr marL="1569659" indent="0">
              <a:buNone/>
              <a:defRPr sz="1144"/>
            </a:lvl4pPr>
            <a:lvl5pPr marL="2092879" indent="0">
              <a:buNone/>
              <a:defRPr sz="1144"/>
            </a:lvl5pPr>
            <a:lvl6pPr marL="2616098" indent="0">
              <a:buNone/>
              <a:defRPr sz="1144"/>
            </a:lvl6pPr>
            <a:lvl7pPr marL="3139318" indent="0">
              <a:buNone/>
              <a:defRPr sz="1144"/>
            </a:lvl7pPr>
            <a:lvl8pPr marL="3662538" indent="0">
              <a:buNone/>
              <a:defRPr sz="1144"/>
            </a:lvl8pPr>
            <a:lvl9pPr marL="4185757" indent="0">
              <a:buNone/>
              <a:defRPr sz="1144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B0C03-E959-4A3B-9766-C52C7221598F}" type="datetimeFigureOut">
              <a:rPr lang="el-GR" smtClean="0"/>
              <a:t>2/6/2024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452DC-F1C0-4F9B-BB8D-5FB30173527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3409308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17867"/>
            <a:ext cx="10515600" cy="15170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089326"/>
            <a:ext cx="10515600" cy="49798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274491"/>
            <a:ext cx="2743200" cy="4178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FB0C03-E959-4A3B-9766-C52C7221598F}" type="datetimeFigureOut">
              <a:rPr lang="el-GR" smtClean="0"/>
              <a:t>2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274491"/>
            <a:ext cx="4114800" cy="4178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274491"/>
            <a:ext cx="2743200" cy="4178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452DC-F1C0-4F9B-BB8D-5FB30173527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748707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46439" rtl="0" eaLnBrk="1" latinLnBrk="0" hangingPunct="1">
        <a:lnSpc>
          <a:spcPct val="90000"/>
        </a:lnSpc>
        <a:spcBef>
          <a:spcPct val="0"/>
        </a:spcBef>
        <a:buNone/>
        <a:defRPr sz="503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1610" indent="-261610" algn="l" defTabSz="1046439" rtl="0" eaLnBrk="1" latinLnBrk="0" hangingPunct="1">
        <a:lnSpc>
          <a:spcPct val="90000"/>
        </a:lnSpc>
        <a:spcBef>
          <a:spcPts val="1144"/>
        </a:spcBef>
        <a:buFont typeface="Arial" panose="020B0604020202020204" pitchFamily="34" charset="0"/>
        <a:buChar char="•"/>
        <a:defRPr sz="3204" kern="1200">
          <a:solidFill>
            <a:schemeClr val="tx1"/>
          </a:solidFill>
          <a:latin typeface="+mn-lt"/>
          <a:ea typeface="+mn-ea"/>
          <a:cs typeface="+mn-cs"/>
        </a:defRPr>
      </a:lvl1pPr>
      <a:lvl2pPr marL="784830" indent="-261610" algn="l" defTabSz="1046439" rtl="0" eaLnBrk="1" latinLnBrk="0" hangingPunct="1">
        <a:lnSpc>
          <a:spcPct val="90000"/>
        </a:lnSpc>
        <a:spcBef>
          <a:spcPts val="572"/>
        </a:spcBef>
        <a:buFont typeface="Arial" panose="020B0604020202020204" pitchFamily="34" charset="0"/>
        <a:buChar char="•"/>
        <a:defRPr sz="2747" kern="1200">
          <a:solidFill>
            <a:schemeClr val="tx1"/>
          </a:solidFill>
          <a:latin typeface="+mn-lt"/>
          <a:ea typeface="+mn-ea"/>
          <a:cs typeface="+mn-cs"/>
        </a:defRPr>
      </a:lvl2pPr>
      <a:lvl3pPr marL="1308049" indent="-261610" algn="l" defTabSz="1046439" rtl="0" eaLnBrk="1" latinLnBrk="0" hangingPunct="1">
        <a:lnSpc>
          <a:spcPct val="90000"/>
        </a:lnSpc>
        <a:spcBef>
          <a:spcPts val="572"/>
        </a:spcBef>
        <a:buFont typeface="Arial" panose="020B0604020202020204" pitchFamily="34" charset="0"/>
        <a:buChar char="•"/>
        <a:defRPr sz="2289" kern="1200">
          <a:solidFill>
            <a:schemeClr val="tx1"/>
          </a:solidFill>
          <a:latin typeface="+mn-lt"/>
          <a:ea typeface="+mn-ea"/>
          <a:cs typeface="+mn-cs"/>
        </a:defRPr>
      </a:lvl3pPr>
      <a:lvl4pPr marL="1831269" indent="-261610" algn="l" defTabSz="1046439" rtl="0" eaLnBrk="1" latinLnBrk="0" hangingPunct="1">
        <a:lnSpc>
          <a:spcPct val="90000"/>
        </a:lnSpc>
        <a:spcBef>
          <a:spcPts val="572"/>
        </a:spcBef>
        <a:buFont typeface="Arial" panose="020B0604020202020204" pitchFamily="34" charset="0"/>
        <a:buChar char="•"/>
        <a:defRPr sz="2060" kern="1200">
          <a:solidFill>
            <a:schemeClr val="tx1"/>
          </a:solidFill>
          <a:latin typeface="+mn-lt"/>
          <a:ea typeface="+mn-ea"/>
          <a:cs typeface="+mn-cs"/>
        </a:defRPr>
      </a:lvl4pPr>
      <a:lvl5pPr marL="2354489" indent="-261610" algn="l" defTabSz="1046439" rtl="0" eaLnBrk="1" latinLnBrk="0" hangingPunct="1">
        <a:lnSpc>
          <a:spcPct val="90000"/>
        </a:lnSpc>
        <a:spcBef>
          <a:spcPts val="572"/>
        </a:spcBef>
        <a:buFont typeface="Arial" panose="020B0604020202020204" pitchFamily="34" charset="0"/>
        <a:buChar char="•"/>
        <a:defRPr sz="2060" kern="1200">
          <a:solidFill>
            <a:schemeClr val="tx1"/>
          </a:solidFill>
          <a:latin typeface="+mn-lt"/>
          <a:ea typeface="+mn-ea"/>
          <a:cs typeface="+mn-cs"/>
        </a:defRPr>
      </a:lvl5pPr>
      <a:lvl6pPr marL="2877708" indent="-261610" algn="l" defTabSz="1046439" rtl="0" eaLnBrk="1" latinLnBrk="0" hangingPunct="1">
        <a:lnSpc>
          <a:spcPct val="90000"/>
        </a:lnSpc>
        <a:spcBef>
          <a:spcPts val="572"/>
        </a:spcBef>
        <a:buFont typeface="Arial" panose="020B0604020202020204" pitchFamily="34" charset="0"/>
        <a:buChar char="•"/>
        <a:defRPr sz="2060" kern="1200">
          <a:solidFill>
            <a:schemeClr val="tx1"/>
          </a:solidFill>
          <a:latin typeface="+mn-lt"/>
          <a:ea typeface="+mn-ea"/>
          <a:cs typeface="+mn-cs"/>
        </a:defRPr>
      </a:lvl6pPr>
      <a:lvl7pPr marL="3400928" indent="-261610" algn="l" defTabSz="1046439" rtl="0" eaLnBrk="1" latinLnBrk="0" hangingPunct="1">
        <a:lnSpc>
          <a:spcPct val="90000"/>
        </a:lnSpc>
        <a:spcBef>
          <a:spcPts val="572"/>
        </a:spcBef>
        <a:buFont typeface="Arial" panose="020B0604020202020204" pitchFamily="34" charset="0"/>
        <a:buChar char="•"/>
        <a:defRPr sz="2060" kern="1200">
          <a:solidFill>
            <a:schemeClr val="tx1"/>
          </a:solidFill>
          <a:latin typeface="+mn-lt"/>
          <a:ea typeface="+mn-ea"/>
          <a:cs typeface="+mn-cs"/>
        </a:defRPr>
      </a:lvl7pPr>
      <a:lvl8pPr marL="3924148" indent="-261610" algn="l" defTabSz="1046439" rtl="0" eaLnBrk="1" latinLnBrk="0" hangingPunct="1">
        <a:lnSpc>
          <a:spcPct val="90000"/>
        </a:lnSpc>
        <a:spcBef>
          <a:spcPts val="572"/>
        </a:spcBef>
        <a:buFont typeface="Arial" panose="020B0604020202020204" pitchFamily="34" charset="0"/>
        <a:buChar char="•"/>
        <a:defRPr sz="2060" kern="1200">
          <a:solidFill>
            <a:schemeClr val="tx1"/>
          </a:solidFill>
          <a:latin typeface="+mn-lt"/>
          <a:ea typeface="+mn-ea"/>
          <a:cs typeface="+mn-cs"/>
        </a:defRPr>
      </a:lvl8pPr>
      <a:lvl9pPr marL="4447367" indent="-261610" algn="l" defTabSz="1046439" rtl="0" eaLnBrk="1" latinLnBrk="0" hangingPunct="1">
        <a:lnSpc>
          <a:spcPct val="90000"/>
        </a:lnSpc>
        <a:spcBef>
          <a:spcPts val="572"/>
        </a:spcBef>
        <a:buFont typeface="Arial" panose="020B0604020202020204" pitchFamily="34" charset="0"/>
        <a:buChar char="•"/>
        <a:defRPr sz="20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46439" rtl="0" eaLnBrk="1" latinLnBrk="0" hangingPunct="1">
        <a:defRPr sz="2060" kern="1200">
          <a:solidFill>
            <a:schemeClr val="tx1"/>
          </a:solidFill>
          <a:latin typeface="+mn-lt"/>
          <a:ea typeface="+mn-ea"/>
          <a:cs typeface="+mn-cs"/>
        </a:defRPr>
      </a:lvl1pPr>
      <a:lvl2pPr marL="523220" algn="l" defTabSz="1046439" rtl="0" eaLnBrk="1" latinLnBrk="0" hangingPunct="1">
        <a:defRPr sz="2060" kern="1200">
          <a:solidFill>
            <a:schemeClr val="tx1"/>
          </a:solidFill>
          <a:latin typeface="+mn-lt"/>
          <a:ea typeface="+mn-ea"/>
          <a:cs typeface="+mn-cs"/>
        </a:defRPr>
      </a:lvl2pPr>
      <a:lvl3pPr marL="1046439" algn="l" defTabSz="1046439" rtl="0" eaLnBrk="1" latinLnBrk="0" hangingPunct="1">
        <a:defRPr sz="2060" kern="1200">
          <a:solidFill>
            <a:schemeClr val="tx1"/>
          </a:solidFill>
          <a:latin typeface="+mn-lt"/>
          <a:ea typeface="+mn-ea"/>
          <a:cs typeface="+mn-cs"/>
        </a:defRPr>
      </a:lvl3pPr>
      <a:lvl4pPr marL="1569659" algn="l" defTabSz="1046439" rtl="0" eaLnBrk="1" latinLnBrk="0" hangingPunct="1">
        <a:defRPr sz="2060" kern="1200">
          <a:solidFill>
            <a:schemeClr val="tx1"/>
          </a:solidFill>
          <a:latin typeface="+mn-lt"/>
          <a:ea typeface="+mn-ea"/>
          <a:cs typeface="+mn-cs"/>
        </a:defRPr>
      </a:lvl4pPr>
      <a:lvl5pPr marL="2092879" algn="l" defTabSz="1046439" rtl="0" eaLnBrk="1" latinLnBrk="0" hangingPunct="1">
        <a:defRPr sz="2060" kern="1200">
          <a:solidFill>
            <a:schemeClr val="tx1"/>
          </a:solidFill>
          <a:latin typeface="+mn-lt"/>
          <a:ea typeface="+mn-ea"/>
          <a:cs typeface="+mn-cs"/>
        </a:defRPr>
      </a:lvl5pPr>
      <a:lvl6pPr marL="2616098" algn="l" defTabSz="1046439" rtl="0" eaLnBrk="1" latinLnBrk="0" hangingPunct="1">
        <a:defRPr sz="2060" kern="1200">
          <a:solidFill>
            <a:schemeClr val="tx1"/>
          </a:solidFill>
          <a:latin typeface="+mn-lt"/>
          <a:ea typeface="+mn-ea"/>
          <a:cs typeface="+mn-cs"/>
        </a:defRPr>
      </a:lvl6pPr>
      <a:lvl7pPr marL="3139318" algn="l" defTabSz="1046439" rtl="0" eaLnBrk="1" latinLnBrk="0" hangingPunct="1">
        <a:defRPr sz="2060" kern="1200">
          <a:solidFill>
            <a:schemeClr val="tx1"/>
          </a:solidFill>
          <a:latin typeface="+mn-lt"/>
          <a:ea typeface="+mn-ea"/>
          <a:cs typeface="+mn-cs"/>
        </a:defRPr>
      </a:lvl7pPr>
      <a:lvl8pPr marL="3662538" algn="l" defTabSz="1046439" rtl="0" eaLnBrk="1" latinLnBrk="0" hangingPunct="1">
        <a:defRPr sz="2060" kern="1200">
          <a:solidFill>
            <a:schemeClr val="tx1"/>
          </a:solidFill>
          <a:latin typeface="+mn-lt"/>
          <a:ea typeface="+mn-ea"/>
          <a:cs typeface="+mn-cs"/>
        </a:defRPr>
      </a:lvl8pPr>
      <a:lvl9pPr marL="4185757" algn="l" defTabSz="1046439" rtl="0" eaLnBrk="1" latinLnBrk="0" hangingPunct="1">
        <a:defRPr sz="20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Εικόνα 4">
            <a:extLst>
              <a:ext uri="{FF2B5EF4-FFF2-40B4-BE49-F238E27FC236}">
                <a16:creationId xmlns:a16="http://schemas.microsoft.com/office/drawing/2014/main" id="{403366B2-06D1-0D0A-39A3-151D0C0FD5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05474" y="1491084"/>
            <a:ext cx="3469065" cy="3469065"/>
          </a:xfrm>
          <a:prstGeom prst="rect">
            <a:avLst/>
          </a:prstGeom>
        </p:spPr>
      </p:pic>
      <p:pic>
        <p:nvPicPr>
          <p:cNvPr id="10" name="Εικόνα 9">
            <a:extLst>
              <a:ext uri="{FF2B5EF4-FFF2-40B4-BE49-F238E27FC236}">
                <a16:creationId xmlns:a16="http://schemas.microsoft.com/office/drawing/2014/main" id="{B343668C-BA96-2ED0-A60E-B6DC3BD035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7333" y="1491086"/>
            <a:ext cx="3479197" cy="3495188"/>
          </a:xfrm>
          <a:prstGeom prst="rect">
            <a:avLst/>
          </a:prstGeom>
        </p:spPr>
      </p:pic>
      <p:pic>
        <p:nvPicPr>
          <p:cNvPr id="12" name="Εικόνα 11">
            <a:extLst>
              <a:ext uri="{FF2B5EF4-FFF2-40B4-BE49-F238E27FC236}">
                <a16:creationId xmlns:a16="http://schemas.microsoft.com/office/drawing/2014/main" id="{4B532D71-F5C6-8F9F-950D-2796C318D6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56400" y="1491089"/>
            <a:ext cx="3479200" cy="3495188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D1AD0DED-A26F-C521-375B-36DD8A68495F}"/>
              </a:ext>
            </a:extLst>
          </p:cNvPr>
          <p:cNvSpPr txBox="1"/>
          <p:nvPr/>
        </p:nvSpPr>
        <p:spPr>
          <a:xfrm>
            <a:off x="1201785" y="1040650"/>
            <a:ext cx="17279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egative control</a:t>
            </a:r>
            <a:endParaRPr lang="el-GR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BD16B0F-9913-FB73-D64C-86D82DB50F30}"/>
              </a:ext>
            </a:extLst>
          </p:cNvPr>
          <p:cNvSpPr txBox="1"/>
          <p:nvPr/>
        </p:nvSpPr>
        <p:spPr>
          <a:xfrm>
            <a:off x="5203386" y="1053710"/>
            <a:ext cx="16287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Positive control</a:t>
            </a:r>
            <a:endParaRPr lang="el-GR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5645480-7C9E-388A-1D36-C6BF003683D8}"/>
              </a:ext>
            </a:extLst>
          </p:cNvPr>
          <p:cNvSpPr txBox="1"/>
          <p:nvPr/>
        </p:nvSpPr>
        <p:spPr>
          <a:xfrm>
            <a:off x="9105792" y="1040650"/>
            <a:ext cx="1638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Positive sample</a:t>
            </a:r>
            <a:endParaRPr lang="el-GR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77A7BC6-9BA4-8FCF-F07E-C73A74650B84}"/>
              </a:ext>
            </a:extLst>
          </p:cNvPr>
          <p:cNvSpPr txBox="1"/>
          <p:nvPr/>
        </p:nvSpPr>
        <p:spPr>
          <a:xfrm>
            <a:off x="478972" y="5699737"/>
            <a:ext cx="96354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resentative confocal microscopy images of samples processed with IFAT method (60X magnitude)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413648118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Θέμα του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</TotalTime>
  <Words>20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Θέμα του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tonia ef</dc:creator>
  <cp:lastModifiedBy>ΑΠΟΛΛΩΝ ΔΑΡΕΙΟΣ ΖΑΡΕ ΧΟΡΜΙΖΙ</cp:lastModifiedBy>
  <cp:revision>3</cp:revision>
  <dcterms:created xsi:type="dcterms:W3CDTF">2024-01-22T12:32:25Z</dcterms:created>
  <dcterms:modified xsi:type="dcterms:W3CDTF">2024-06-02T07:58:38Z</dcterms:modified>
</cp:coreProperties>
</file>